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4" d="100"/>
          <a:sy n="104" d="100"/>
        </p:scale>
        <p:origin x="186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HM3\Experiment\Animal%20experiment\mice%20weight%20raw%20data%20and%20analysis%2020230323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095695044578613"/>
          <c:y val="6.6237268721100528E-2"/>
          <c:w val="0.84061168053462121"/>
          <c:h val="0.73193280237034031"/>
        </c:manualLayout>
      </c:layout>
      <c:lineChart>
        <c:grouping val="standard"/>
        <c:varyColors val="0"/>
        <c:ser>
          <c:idx val="0"/>
          <c:order val="0"/>
          <c:tx>
            <c:strRef>
              <c:f>'Body wt analysis'!$A$4</c:f>
              <c:strCache>
                <c:ptCount val="1"/>
                <c:pt idx="0">
                  <c:v>Old Vehicle</c:v>
                </c:pt>
              </c:strCache>
            </c:strRef>
          </c:tx>
          <c:spPr>
            <a:ln w="25400" cap="rnd">
              <a:solidFill>
                <a:srgbClr val="FF0000"/>
              </a:solidFill>
              <a:round/>
            </a:ln>
            <a:effectLst/>
          </c:spPr>
          <c:marker>
            <c:symbol val="triang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Body wt analysis'!$C$5:$AD$5</c:f>
                <c:numCache>
                  <c:formatCode>General</c:formatCode>
                  <c:ptCount val="28"/>
                  <c:pt idx="0">
                    <c:v>0.2538503496156741</c:v>
                  </c:pt>
                  <c:pt idx="1">
                    <c:v>0.21938297310613897</c:v>
                  </c:pt>
                  <c:pt idx="2">
                    <c:v>0.22021454185508382</c:v>
                  </c:pt>
                  <c:pt idx="3">
                    <c:v>0.20256411879259914</c:v>
                  </c:pt>
                  <c:pt idx="4">
                    <c:v>0.18441800345953213</c:v>
                  </c:pt>
                  <c:pt idx="5">
                    <c:v>0.18832890850259223</c:v>
                  </c:pt>
                  <c:pt idx="6">
                    <c:v>0.18178436554213226</c:v>
                  </c:pt>
                  <c:pt idx="7">
                    <c:v>0.19537997167911897</c:v>
                  </c:pt>
                  <c:pt idx="8">
                    <c:v>0.20996295969633422</c:v>
                  </c:pt>
                  <c:pt idx="9">
                    <c:v>0.21599639914694055</c:v>
                  </c:pt>
                  <c:pt idx="10">
                    <c:v>0.20382181760874696</c:v>
                  </c:pt>
                  <c:pt idx="11">
                    <c:v>0.20115223643355845</c:v>
                  </c:pt>
                  <c:pt idx="12">
                    <c:v>0.18938790293410449</c:v>
                  </c:pt>
                  <c:pt idx="13">
                    <c:v>0.20976441812450258</c:v>
                  </c:pt>
                  <c:pt idx="14">
                    <c:v>0.20146408557799528</c:v>
                  </c:pt>
                  <c:pt idx="15">
                    <c:v>0.19231051279982939</c:v>
                  </c:pt>
                  <c:pt idx="16">
                    <c:v>0.19180140191817624</c:v>
                  </c:pt>
                  <c:pt idx="17">
                    <c:v>0.18927052948975792</c:v>
                  </c:pt>
                  <c:pt idx="18">
                    <c:v>0.20801709331473489</c:v>
                  </c:pt>
                  <c:pt idx="19">
                    <c:v>0.20030254893812782</c:v>
                  </c:pt>
                  <c:pt idx="20">
                    <c:v>0.20677685234732307</c:v>
                  </c:pt>
                  <c:pt idx="21">
                    <c:v>0.18774687451163835</c:v>
                  </c:pt>
                  <c:pt idx="22">
                    <c:v>0.16665333279995731</c:v>
                  </c:pt>
                  <c:pt idx="23">
                    <c:v>0.17438463235044532</c:v>
                  </c:pt>
                  <c:pt idx="24">
                    <c:v>0.14878769363686561</c:v>
                  </c:pt>
                  <c:pt idx="25">
                    <c:v>0.17434321195720687</c:v>
                  </c:pt>
                  <c:pt idx="26">
                    <c:v>0.16201508846057791</c:v>
                  </c:pt>
                  <c:pt idx="27">
                    <c:v>0.1600555459138413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Body wt analysis'!$C$3:$AD$3</c:f>
              <c:numCache>
                <c:formatCode>General</c:formatCode>
                <c:ptCount val="28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</c:numCache>
            </c:numRef>
          </c:cat>
          <c:val>
            <c:numRef>
              <c:f>'Body wt analysis'!$C$4:$AD$4</c:f>
              <c:numCache>
                <c:formatCode>0.00</c:formatCode>
                <c:ptCount val="28"/>
                <c:pt idx="0">
                  <c:v>32.78</c:v>
                </c:pt>
                <c:pt idx="1">
                  <c:v>32.72</c:v>
                </c:pt>
                <c:pt idx="2">
                  <c:v>32.549999999999997</c:v>
                </c:pt>
                <c:pt idx="3">
                  <c:v>32.39</c:v>
                </c:pt>
                <c:pt idx="4">
                  <c:v>32.510000000000005</c:v>
                </c:pt>
                <c:pt idx="5">
                  <c:v>32.470000000000006</c:v>
                </c:pt>
                <c:pt idx="6">
                  <c:v>31.97</c:v>
                </c:pt>
                <c:pt idx="7">
                  <c:v>32.179999999999993</c:v>
                </c:pt>
                <c:pt idx="8">
                  <c:v>31.98</c:v>
                </c:pt>
                <c:pt idx="9">
                  <c:v>32.190000000000005</c:v>
                </c:pt>
                <c:pt idx="10">
                  <c:v>32.11</c:v>
                </c:pt>
                <c:pt idx="11">
                  <c:v>32.22</c:v>
                </c:pt>
                <c:pt idx="12">
                  <c:v>31.669999999999998</c:v>
                </c:pt>
                <c:pt idx="13">
                  <c:v>31.830000000000002</c:v>
                </c:pt>
                <c:pt idx="14">
                  <c:v>32.19</c:v>
                </c:pt>
                <c:pt idx="15">
                  <c:v>31.95</c:v>
                </c:pt>
                <c:pt idx="16">
                  <c:v>31.690000000000005</c:v>
                </c:pt>
                <c:pt idx="17">
                  <c:v>31.869999999999997</c:v>
                </c:pt>
                <c:pt idx="18">
                  <c:v>31.46</c:v>
                </c:pt>
                <c:pt idx="19">
                  <c:v>31.589999999999996</c:v>
                </c:pt>
                <c:pt idx="20">
                  <c:v>31.57</c:v>
                </c:pt>
                <c:pt idx="21">
                  <c:v>31.74</c:v>
                </c:pt>
                <c:pt idx="22">
                  <c:v>31.42</c:v>
                </c:pt>
                <c:pt idx="23">
                  <c:v>31.79</c:v>
                </c:pt>
                <c:pt idx="24">
                  <c:v>31.559999999999995</c:v>
                </c:pt>
                <c:pt idx="25">
                  <c:v>32.08</c:v>
                </c:pt>
                <c:pt idx="26">
                  <c:v>31.639999999999997</c:v>
                </c:pt>
                <c:pt idx="27">
                  <c:v>31.77999999999999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EF7-45CD-A49A-28048C003216}"/>
            </c:ext>
          </c:extLst>
        </c:ser>
        <c:ser>
          <c:idx val="1"/>
          <c:order val="1"/>
          <c:tx>
            <c:strRef>
              <c:f>'Body wt analysis'!$A$6</c:f>
              <c:strCache>
                <c:ptCount val="1"/>
                <c:pt idx="0">
                  <c:v>Old Baicalin</c:v>
                </c:pt>
              </c:strCache>
            </c:strRef>
          </c:tx>
          <c:spPr>
            <a:ln w="25400" cap="rnd" cmpd="sng">
              <a:solidFill>
                <a:srgbClr val="00B050"/>
              </a:solidFill>
              <a:round/>
            </a:ln>
            <a:effectLst/>
          </c:spPr>
          <c:marker>
            <c:symbol val="diamond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4EF7-45CD-A49A-28048C003216}"/>
                </c:ext>
              </c:extLst>
            </c:dLbl>
            <c:dLbl>
              <c:idx val="1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4EF7-45CD-A49A-28048C003216}"/>
                </c:ext>
              </c:extLst>
            </c:dLbl>
            <c:dLbl>
              <c:idx val="2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4EF7-45CD-A49A-28048C003216}"/>
                </c:ext>
              </c:extLst>
            </c:dLbl>
            <c:dLbl>
              <c:idx val="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4-4EF7-45CD-A49A-28048C003216}"/>
                </c:ext>
              </c:extLst>
            </c:dLbl>
            <c:dLbl>
              <c:idx val="4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4EF7-45CD-A49A-28048C003216}"/>
                </c:ext>
              </c:extLst>
            </c:dLbl>
            <c:dLbl>
              <c:idx val="5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6-4EF7-45CD-A49A-28048C003216}"/>
                </c:ext>
              </c:extLst>
            </c:dLbl>
            <c:dLbl>
              <c:idx val="6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4EF7-45CD-A49A-28048C003216}"/>
                </c:ext>
              </c:extLst>
            </c:dLbl>
            <c:dLbl>
              <c:idx val="7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8-4EF7-45CD-A49A-28048C003216}"/>
                </c:ext>
              </c:extLst>
            </c:dLbl>
            <c:dLbl>
              <c:idx val="8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4EF7-45CD-A49A-28048C003216}"/>
                </c:ext>
              </c:extLst>
            </c:dLbl>
            <c:dLbl>
              <c:idx val="9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A-4EF7-45CD-A49A-28048C003216}"/>
                </c:ext>
              </c:extLst>
            </c:dLbl>
            <c:dLbl>
              <c:idx val="1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4EF7-45CD-A49A-28048C003216}"/>
                </c:ext>
              </c:extLst>
            </c:dLbl>
            <c:dLbl>
              <c:idx val="11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C-4EF7-45CD-A49A-28048C003216}"/>
                </c:ext>
              </c:extLst>
            </c:dLbl>
            <c:dLbl>
              <c:idx val="12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D-4EF7-45CD-A49A-28048C003216}"/>
                </c:ext>
              </c:extLst>
            </c:dLbl>
            <c:dLbl>
              <c:idx val="1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E-4EF7-45CD-A49A-28048C003216}"/>
                </c:ext>
              </c:extLst>
            </c:dLbl>
            <c:dLbl>
              <c:idx val="14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F-4EF7-45CD-A49A-28048C003216}"/>
                </c:ext>
              </c:extLst>
            </c:dLbl>
            <c:dLbl>
              <c:idx val="15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0-4EF7-45CD-A49A-28048C003216}"/>
                </c:ext>
              </c:extLst>
            </c:dLbl>
            <c:dLbl>
              <c:idx val="16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1-4EF7-45CD-A49A-28048C003216}"/>
                </c:ext>
              </c:extLst>
            </c:dLbl>
            <c:dLbl>
              <c:idx val="17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2-4EF7-45CD-A49A-28048C003216}"/>
                </c:ext>
              </c:extLst>
            </c:dLbl>
            <c:dLbl>
              <c:idx val="18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3-4EF7-45CD-A49A-28048C003216}"/>
                </c:ext>
              </c:extLst>
            </c:dLbl>
            <c:dLbl>
              <c:idx val="19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4-4EF7-45CD-A49A-28048C003216}"/>
                </c:ext>
              </c:extLst>
            </c:dLbl>
            <c:dLbl>
              <c:idx val="2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5-4EF7-45CD-A49A-28048C003216}"/>
                </c:ext>
              </c:extLst>
            </c:dLbl>
            <c:dLbl>
              <c:idx val="21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6-4EF7-45CD-A49A-28048C003216}"/>
                </c:ext>
              </c:extLst>
            </c:dLbl>
            <c:dLbl>
              <c:idx val="22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7-4EF7-45CD-A49A-28048C003216}"/>
                </c:ext>
              </c:extLst>
            </c:dLbl>
            <c:dLbl>
              <c:idx val="2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8-4EF7-45CD-A49A-28048C003216}"/>
                </c:ext>
              </c:extLst>
            </c:dLbl>
            <c:dLbl>
              <c:idx val="24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9-4EF7-45CD-A49A-28048C003216}"/>
                </c:ext>
              </c:extLst>
            </c:dLbl>
            <c:dLbl>
              <c:idx val="25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A-4EF7-45CD-A49A-28048C003216}"/>
                </c:ext>
              </c:extLst>
            </c:dLbl>
            <c:dLbl>
              <c:idx val="26"/>
              <c:tx>
                <c:rich>
                  <a:bodyPr/>
                  <a:lstStyle/>
                  <a:p>
                    <a:r>
                      <a:rPr lang="en-US" sz="1400" b="1"/>
                      <a:t>*</a:t>
                    </a:r>
                  </a:p>
                </c:rich>
              </c:tx>
              <c:dLblPos val="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1B-4EF7-45CD-A49A-28048C003216}"/>
                </c:ext>
              </c:extLst>
            </c:dLbl>
            <c:dLbl>
              <c:idx val="27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C-4EF7-45CD-A49A-28048C003216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Dir val="y"/>
            <c:errBarType val="plus"/>
            <c:errValType val="cust"/>
            <c:noEndCap val="0"/>
            <c:plus>
              <c:numRef>
                <c:f>'Body wt analysis'!$C$7:$AD$7</c:f>
                <c:numCache>
                  <c:formatCode>General</c:formatCode>
                  <c:ptCount val="28"/>
                  <c:pt idx="0">
                    <c:v>0.17663836251253889</c:v>
                  </c:pt>
                  <c:pt idx="1">
                    <c:v>0.16043344068145171</c:v>
                  </c:pt>
                  <c:pt idx="2">
                    <c:v>0.19922349259060787</c:v>
                  </c:pt>
                  <c:pt idx="3">
                    <c:v>0.20611755006414287</c:v>
                  </c:pt>
                  <c:pt idx="4">
                    <c:v>0.20900824013527425</c:v>
                  </c:pt>
                  <c:pt idx="5">
                    <c:v>0.18736773112429642</c:v>
                  </c:pt>
                  <c:pt idx="6">
                    <c:v>0.196965874088776</c:v>
                  </c:pt>
                  <c:pt idx="7">
                    <c:v>0.20073199379603976</c:v>
                  </c:pt>
                  <c:pt idx="8">
                    <c:v>0.19604137885207351</c:v>
                  </c:pt>
                  <c:pt idx="9">
                    <c:v>0.21143951065651528</c:v>
                  </c:pt>
                  <c:pt idx="10">
                    <c:v>0.207589338197638</c:v>
                  </c:pt>
                  <c:pt idx="11">
                    <c:v>0.19460501306778075</c:v>
                  </c:pt>
                  <c:pt idx="12">
                    <c:v>0.18477914745266394</c:v>
                  </c:pt>
                  <c:pt idx="13">
                    <c:v>0.18595100907975129</c:v>
                  </c:pt>
                  <c:pt idx="14">
                    <c:v>0.18233363802533956</c:v>
                  </c:pt>
                  <c:pt idx="15">
                    <c:v>0.16534139765278927</c:v>
                  </c:pt>
                  <c:pt idx="16">
                    <c:v>0.16146551059316389</c:v>
                  </c:pt>
                  <c:pt idx="17">
                    <c:v>0.17164562977897865</c:v>
                  </c:pt>
                  <c:pt idx="18">
                    <c:v>0.14898172893195855</c:v>
                  </c:pt>
                  <c:pt idx="19">
                    <c:v>0.16554623389118692</c:v>
                  </c:pt>
                  <c:pt idx="20">
                    <c:v>0.14228297313608701</c:v>
                  </c:pt>
                  <c:pt idx="21">
                    <c:v>0.15333333333333335</c:v>
                  </c:pt>
                  <c:pt idx="22">
                    <c:v>0.14109098719148111</c:v>
                  </c:pt>
                  <c:pt idx="23">
                    <c:v>0.15418603481941331</c:v>
                  </c:pt>
                  <c:pt idx="24">
                    <c:v>0.14502490207623725</c:v>
                  </c:pt>
                  <c:pt idx="25">
                    <c:v>0.14088608479508857</c:v>
                  </c:pt>
                  <c:pt idx="26">
                    <c:v>0.16493769867572566</c:v>
                  </c:pt>
                  <c:pt idx="27">
                    <c:v>0.1359084659287680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Body wt analysis'!$C$3:$AD$3</c:f>
              <c:numCache>
                <c:formatCode>General</c:formatCode>
                <c:ptCount val="28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</c:numCache>
            </c:numRef>
          </c:cat>
          <c:val>
            <c:numRef>
              <c:f>'Body wt analysis'!$C$6:$AD$6</c:f>
              <c:numCache>
                <c:formatCode>0.00</c:formatCode>
                <c:ptCount val="28"/>
                <c:pt idx="0">
                  <c:v>32.270000000000003</c:v>
                </c:pt>
                <c:pt idx="1">
                  <c:v>33.450000000000003</c:v>
                </c:pt>
                <c:pt idx="2">
                  <c:v>32.869999999999997</c:v>
                </c:pt>
                <c:pt idx="3">
                  <c:v>33.22</c:v>
                </c:pt>
                <c:pt idx="4">
                  <c:v>33.180000000000007</c:v>
                </c:pt>
                <c:pt idx="5">
                  <c:v>33.120000000000005</c:v>
                </c:pt>
                <c:pt idx="6">
                  <c:v>32.92</c:v>
                </c:pt>
                <c:pt idx="7">
                  <c:v>32.760000000000005</c:v>
                </c:pt>
                <c:pt idx="8">
                  <c:v>32.409999999999997</c:v>
                </c:pt>
                <c:pt idx="9">
                  <c:v>32.519999999999996</c:v>
                </c:pt>
                <c:pt idx="10">
                  <c:v>32.559999999999995</c:v>
                </c:pt>
                <c:pt idx="11">
                  <c:v>32.74</c:v>
                </c:pt>
                <c:pt idx="12">
                  <c:v>31.889999999999997</c:v>
                </c:pt>
                <c:pt idx="13">
                  <c:v>32.000000000000007</c:v>
                </c:pt>
                <c:pt idx="14">
                  <c:v>32.83</c:v>
                </c:pt>
                <c:pt idx="15">
                  <c:v>32.340000000000003</c:v>
                </c:pt>
                <c:pt idx="16">
                  <c:v>32.559999999999995</c:v>
                </c:pt>
                <c:pt idx="17">
                  <c:v>32.480000000000004</c:v>
                </c:pt>
                <c:pt idx="18">
                  <c:v>32.22</c:v>
                </c:pt>
                <c:pt idx="19">
                  <c:v>32.450000000000003</c:v>
                </c:pt>
                <c:pt idx="20">
                  <c:v>32.1</c:v>
                </c:pt>
                <c:pt idx="21">
                  <c:v>32.299999999999997</c:v>
                </c:pt>
                <c:pt idx="22">
                  <c:v>32.32</c:v>
                </c:pt>
                <c:pt idx="23">
                  <c:v>32.519999999999996</c:v>
                </c:pt>
                <c:pt idx="24">
                  <c:v>32.190000000000005</c:v>
                </c:pt>
                <c:pt idx="25">
                  <c:v>32.239999999999995</c:v>
                </c:pt>
                <c:pt idx="26">
                  <c:v>33.260000000000005</c:v>
                </c:pt>
                <c:pt idx="27">
                  <c:v>32.25999999999999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D-4EF7-45CD-A49A-28048C003216}"/>
            </c:ext>
          </c:extLst>
        </c:ser>
        <c:ser>
          <c:idx val="2"/>
          <c:order val="2"/>
          <c:tx>
            <c:strRef>
              <c:f>'Body wt analysis'!$A$8</c:f>
              <c:strCache>
                <c:ptCount val="1"/>
                <c:pt idx="0">
                  <c:v>Young Vehicle</c:v>
                </c:pt>
              </c:strCache>
            </c:strRef>
          </c:tx>
          <c:spPr>
            <a:ln w="25400" cap="rnd">
              <a:solidFill>
                <a:srgbClr val="0070C0">
                  <a:alpha val="95000"/>
                </a:srgb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70C0"/>
              </a:solidFill>
              <a:ln w="9525">
                <a:solidFill>
                  <a:srgbClr val="0070C0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Body wt analysis'!$C$9:$AD$9</c:f>
                <c:numCache>
                  <c:formatCode>General</c:formatCode>
                  <c:ptCount val="28"/>
                  <c:pt idx="0">
                    <c:v>8.2731157639939101E-2</c:v>
                  </c:pt>
                  <c:pt idx="1">
                    <c:v>9.9045444115315087E-2</c:v>
                  </c:pt>
                  <c:pt idx="2">
                    <c:v>8.9715600030813455E-2</c:v>
                  </c:pt>
                  <c:pt idx="3">
                    <c:v>0.10926522268722509</c:v>
                  </c:pt>
                  <c:pt idx="4">
                    <c:v>0.10145606602531627</c:v>
                  </c:pt>
                  <c:pt idx="5">
                    <c:v>0.11347540115226151</c:v>
                  </c:pt>
                  <c:pt idx="6">
                    <c:v>0.12009255689767884</c:v>
                  </c:pt>
                  <c:pt idx="7">
                    <c:v>0.11501207666057411</c:v>
                  </c:pt>
                  <c:pt idx="8">
                    <c:v>0.11219526628952663</c:v>
                  </c:pt>
                  <c:pt idx="9">
                    <c:v>0.12329278612762029</c:v>
                  </c:pt>
                  <c:pt idx="10">
                    <c:v>0.12463279397226608</c:v>
                  </c:pt>
                  <c:pt idx="11">
                    <c:v>0.12547244053310408</c:v>
                  </c:pt>
                  <c:pt idx="12">
                    <c:v>0.13222875800840167</c:v>
                  </c:pt>
                  <c:pt idx="13">
                    <c:v>0.13466419139639332</c:v>
                  </c:pt>
                  <c:pt idx="14">
                    <c:v>0.1636255888708528</c:v>
                  </c:pt>
                  <c:pt idx="15">
                    <c:v>0.15329347307987012</c:v>
                  </c:pt>
                  <c:pt idx="16">
                    <c:v>0.15882904856060392</c:v>
                  </c:pt>
                  <c:pt idx="17">
                    <c:v>0.15211472278806187</c:v>
                  </c:pt>
                  <c:pt idx="18">
                    <c:v>0.15018877010837622</c:v>
                  </c:pt>
                  <c:pt idx="19">
                    <c:v>0.1595862706431157</c:v>
                  </c:pt>
                  <c:pt idx="20">
                    <c:v>0.1514558975044844</c:v>
                  </c:pt>
                  <c:pt idx="21">
                    <c:v>0.14017449443065197</c:v>
                  </c:pt>
                  <c:pt idx="22">
                    <c:v>0.13984515246037912</c:v>
                  </c:pt>
                  <c:pt idx="23">
                    <c:v>0.14996295838935991</c:v>
                  </c:pt>
                  <c:pt idx="24">
                    <c:v>0.14974051630144136</c:v>
                  </c:pt>
                  <c:pt idx="25">
                    <c:v>0.15394443441998434</c:v>
                  </c:pt>
                  <c:pt idx="26">
                    <c:v>0.19818341672972212</c:v>
                  </c:pt>
                  <c:pt idx="27">
                    <c:v>0.1408900280360537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Body wt analysis'!$C$3:$AD$3</c:f>
              <c:numCache>
                <c:formatCode>General</c:formatCode>
                <c:ptCount val="28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</c:numCache>
            </c:numRef>
          </c:cat>
          <c:val>
            <c:numRef>
              <c:f>'Body wt analysis'!$C$8:$AD$8</c:f>
              <c:numCache>
                <c:formatCode>0.00</c:formatCode>
                <c:ptCount val="28"/>
                <c:pt idx="0">
                  <c:v>21.8</c:v>
                </c:pt>
                <c:pt idx="1">
                  <c:v>22.21</c:v>
                </c:pt>
                <c:pt idx="2">
                  <c:v>22.240000000000002</c:v>
                </c:pt>
                <c:pt idx="3">
                  <c:v>22.45</c:v>
                </c:pt>
                <c:pt idx="4">
                  <c:v>22.34</c:v>
                </c:pt>
                <c:pt idx="5">
                  <c:v>22.389999999999997</c:v>
                </c:pt>
                <c:pt idx="6">
                  <c:v>22.3</c:v>
                </c:pt>
                <c:pt idx="7">
                  <c:v>22.250000000000004</c:v>
                </c:pt>
                <c:pt idx="8">
                  <c:v>22.31</c:v>
                </c:pt>
                <c:pt idx="9">
                  <c:v>22.43</c:v>
                </c:pt>
                <c:pt idx="10">
                  <c:v>22.499999999999996</c:v>
                </c:pt>
                <c:pt idx="11">
                  <c:v>22.81</c:v>
                </c:pt>
                <c:pt idx="12">
                  <c:v>22.48</c:v>
                </c:pt>
                <c:pt idx="13">
                  <c:v>22.73</c:v>
                </c:pt>
                <c:pt idx="14">
                  <c:v>23.22</c:v>
                </c:pt>
                <c:pt idx="15">
                  <c:v>23.110000000000003</c:v>
                </c:pt>
                <c:pt idx="16">
                  <c:v>23.26</c:v>
                </c:pt>
                <c:pt idx="17">
                  <c:v>23.15</c:v>
                </c:pt>
                <c:pt idx="18">
                  <c:v>23.07</c:v>
                </c:pt>
                <c:pt idx="19">
                  <c:v>23.43</c:v>
                </c:pt>
                <c:pt idx="20">
                  <c:v>23.55</c:v>
                </c:pt>
                <c:pt idx="21">
                  <c:v>23.639999999999997</c:v>
                </c:pt>
                <c:pt idx="22">
                  <c:v>23.53</c:v>
                </c:pt>
                <c:pt idx="23">
                  <c:v>23.800000000000004</c:v>
                </c:pt>
                <c:pt idx="24">
                  <c:v>23.8</c:v>
                </c:pt>
                <c:pt idx="25">
                  <c:v>23.91</c:v>
                </c:pt>
                <c:pt idx="26">
                  <c:v>24.41</c:v>
                </c:pt>
                <c:pt idx="27">
                  <c:v>24.1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E-4EF7-45CD-A49A-28048C003216}"/>
            </c:ext>
          </c:extLst>
        </c:ser>
        <c:ser>
          <c:idx val="3"/>
          <c:order val="3"/>
          <c:tx>
            <c:strRef>
              <c:f>'Body wt analysis'!$A$10</c:f>
              <c:strCache>
                <c:ptCount val="1"/>
                <c:pt idx="0">
                  <c:v>Young Baicalin</c:v>
                </c:pt>
              </c:strCache>
            </c:strRef>
          </c:tx>
          <c:spPr>
            <a:ln w="25400" cap="rnd">
              <a:solidFill>
                <a:srgbClr val="7030A0"/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rgbClr val="7030A0"/>
              </a:solidFill>
              <a:ln w="9525">
                <a:solidFill>
                  <a:srgbClr val="7030A0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Body wt analysis'!$C$11:$AD$11</c:f>
                <c:numCache>
                  <c:formatCode>General</c:formatCode>
                  <c:ptCount val="28"/>
                  <c:pt idx="0">
                    <c:v>0.10999494937900052</c:v>
                  </c:pt>
                  <c:pt idx="1">
                    <c:v>0.11817595168034636</c:v>
                  </c:pt>
                  <c:pt idx="2">
                    <c:v>0.12553883861180171</c:v>
                  </c:pt>
                  <c:pt idx="3">
                    <c:v>0.13993649353268156</c:v>
                  </c:pt>
                  <c:pt idx="4">
                    <c:v>0.12348639151294727</c:v>
                  </c:pt>
                  <c:pt idx="5">
                    <c:v>0.10710327311110104</c:v>
                  </c:pt>
                  <c:pt idx="6">
                    <c:v>0.11976365614548239</c:v>
                  </c:pt>
                  <c:pt idx="7">
                    <c:v>0.11469767022723501</c:v>
                  </c:pt>
                  <c:pt idx="8">
                    <c:v>0.11877148928369412</c:v>
                  </c:pt>
                  <c:pt idx="9">
                    <c:v>0.13411852138231228</c:v>
                  </c:pt>
                  <c:pt idx="10">
                    <c:v>0.14389811210251044</c:v>
                  </c:pt>
                  <c:pt idx="11">
                    <c:v>0.14320148975016517</c:v>
                  </c:pt>
                  <c:pt idx="12">
                    <c:v>0.13540474306479977</c:v>
                  </c:pt>
                  <c:pt idx="13">
                    <c:v>0.12321616055624454</c:v>
                  </c:pt>
                  <c:pt idx="14">
                    <c:v>0.15376750126227728</c:v>
                  </c:pt>
                  <c:pt idx="15">
                    <c:v>0.16875030864169308</c:v>
                  </c:pt>
                  <c:pt idx="16">
                    <c:v>0.16228917948457861</c:v>
                  </c:pt>
                  <c:pt idx="17">
                    <c:v>0.16542537760439163</c:v>
                  </c:pt>
                  <c:pt idx="18">
                    <c:v>0.16952548153268554</c:v>
                  </c:pt>
                  <c:pt idx="19">
                    <c:v>0.17103930672346765</c:v>
                  </c:pt>
                  <c:pt idx="20">
                    <c:v>0.17638657041345926</c:v>
                  </c:pt>
                  <c:pt idx="21">
                    <c:v>0.15753659186924723</c:v>
                  </c:pt>
                  <c:pt idx="22">
                    <c:v>0.14317433041187541</c:v>
                  </c:pt>
                  <c:pt idx="23">
                    <c:v>0.14257941257028967</c:v>
                  </c:pt>
                  <c:pt idx="24">
                    <c:v>0.1513494851879803</c:v>
                  </c:pt>
                  <c:pt idx="25">
                    <c:v>0.16141389173316045</c:v>
                  </c:pt>
                  <c:pt idx="26">
                    <c:v>0.16806414119482938</c:v>
                  </c:pt>
                  <c:pt idx="27">
                    <c:v>0.1571128398459032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Body wt analysis'!$C$3:$AD$3</c:f>
              <c:numCache>
                <c:formatCode>General</c:formatCode>
                <c:ptCount val="28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</c:numCache>
            </c:numRef>
          </c:cat>
          <c:val>
            <c:numRef>
              <c:f>'Body wt analysis'!$C$10:$AD$10</c:f>
              <c:numCache>
                <c:formatCode>0.00</c:formatCode>
                <c:ptCount val="28"/>
                <c:pt idx="0">
                  <c:v>21.59</c:v>
                </c:pt>
                <c:pt idx="1">
                  <c:v>21.99</c:v>
                </c:pt>
                <c:pt idx="2">
                  <c:v>21.839999999999996</c:v>
                </c:pt>
                <c:pt idx="3">
                  <c:v>21.84</c:v>
                </c:pt>
                <c:pt idx="4">
                  <c:v>21.94</c:v>
                </c:pt>
                <c:pt idx="5">
                  <c:v>22.04</c:v>
                </c:pt>
                <c:pt idx="6">
                  <c:v>21.810000000000002</c:v>
                </c:pt>
                <c:pt idx="7">
                  <c:v>22</c:v>
                </c:pt>
                <c:pt idx="8">
                  <c:v>22.18</c:v>
                </c:pt>
                <c:pt idx="9">
                  <c:v>22.189999999999998</c:v>
                </c:pt>
                <c:pt idx="10">
                  <c:v>22.42</c:v>
                </c:pt>
                <c:pt idx="11">
                  <c:v>22.619999999999997</c:v>
                </c:pt>
                <c:pt idx="12">
                  <c:v>22.230000000000004</c:v>
                </c:pt>
                <c:pt idx="13">
                  <c:v>22.34</c:v>
                </c:pt>
                <c:pt idx="14">
                  <c:v>22.9</c:v>
                </c:pt>
                <c:pt idx="15">
                  <c:v>23.090000000000003</c:v>
                </c:pt>
                <c:pt idx="16">
                  <c:v>23.14</c:v>
                </c:pt>
                <c:pt idx="17">
                  <c:v>23.21</c:v>
                </c:pt>
                <c:pt idx="18">
                  <c:v>23.35</c:v>
                </c:pt>
                <c:pt idx="19">
                  <c:v>23.61</c:v>
                </c:pt>
                <c:pt idx="20">
                  <c:v>23.57</c:v>
                </c:pt>
                <c:pt idx="21">
                  <c:v>23.580000000000005</c:v>
                </c:pt>
                <c:pt idx="22">
                  <c:v>23.689999999999998</c:v>
                </c:pt>
                <c:pt idx="23">
                  <c:v>23.98</c:v>
                </c:pt>
                <c:pt idx="24">
                  <c:v>24.080000000000002</c:v>
                </c:pt>
                <c:pt idx="25">
                  <c:v>24.09</c:v>
                </c:pt>
                <c:pt idx="26">
                  <c:v>24.37</c:v>
                </c:pt>
                <c:pt idx="27">
                  <c:v>24.1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F-4EF7-45CD-A49A-28048C00321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92443983"/>
        <c:axId val="1792446063"/>
      </c:lineChart>
      <c:catAx>
        <c:axId val="1792443983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s</a:t>
                </a:r>
              </a:p>
            </c:rich>
          </c:tx>
          <c:layout>
            <c:manualLayout>
              <c:xMode val="edge"/>
              <c:yMode val="edge"/>
              <c:x val="0.51733810114338385"/>
              <c:y val="0.886847349194692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792446063"/>
        <c:crosses val="autoZero"/>
        <c:auto val="1"/>
        <c:lblAlgn val="ctr"/>
        <c:lblOffset val="100"/>
        <c:tickMarkSkip val="1"/>
        <c:noMultiLvlLbl val="0"/>
      </c:catAx>
      <c:valAx>
        <c:axId val="1792446063"/>
        <c:scaling>
          <c:orientation val="minMax"/>
          <c:max val="35"/>
          <c:min val="2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ody Weight (g)</a:t>
                </a:r>
              </a:p>
            </c:rich>
          </c:tx>
          <c:layout>
            <c:manualLayout>
              <c:xMode val="edge"/>
              <c:yMode val="edge"/>
              <c:x val="2.9245626217965778E-2"/>
              <c:y val="0.3144994207100890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 w="15875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792443983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9490934118768299"/>
          <c:y val="0.31169794734627637"/>
          <c:w val="0.3019141187872495"/>
          <c:h val="0.2869918045958541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ABAAD-8FF2-4C05-9F9A-E686BFC8756C}" type="datetimeFigureOut">
              <a:rPr lang="ko-KR" altLang="en-US" smtClean="0"/>
              <a:t>2025-08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29D6B-4211-4370-A671-07C90A0516A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32389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ABAAD-8FF2-4C05-9F9A-E686BFC8756C}" type="datetimeFigureOut">
              <a:rPr lang="ko-KR" altLang="en-US" smtClean="0"/>
              <a:t>2025-08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29D6B-4211-4370-A671-07C90A0516A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372670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ABAAD-8FF2-4C05-9F9A-E686BFC8756C}" type="datetimeFigureOut">
              <a:rPr lang="ko-KR" altLang="en-US" smtClean="0"/>
              <a:t>2025-08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29D6B-4211-4370-A671-07C90A0516A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56335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ABAAD-8FF2-4C05-9F9A-E686BFC8756C}" type="datetimeFigureOut">
              <a:rPr lang="ko-KR" altLang="en-US" smtClean="0"/>
              <a:t>2025-08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29D6B-4211-4370-A671-07C90A0516A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713493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ABAAD-8FF2-4C05-9F9A-E686BFC8756C}" type="datetimeFigureOut">
              <a:rPr lang="ko-KR" altLang="en-US" smtClean="0"/>
              <a:t>2025-08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29D6B-4211-4370-A671-07C90A0516A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70358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ABAAD-8FF2-4C05-9F9A-E686BFC8756C}" type="datetimeFigureOut">
              <a:rPr lang="ko-KR" altLang="en-US" smtClean="0"/>
              <a:t>2025-08-0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29D6B-4211-4370-A671-07C90A0516A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770970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ABAAD-8FF2-4C05-9F9A-E686BFC8756C}" type="datetimeFigureOut">
              <a:rPr lang="ko-KR" altLang="en-US" smtClean="0"/>
              <a:t>2025-08-07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29D6B-4211-4370-A671-07C90A0516A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221875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ABAAD-8FF2-4C05-9F9A-E686BFC8756C}" type="datetimeFigureOut">
              <a:rPr lang="ko-KR" altLang="en-US" smtClean="0"/>
              <a:t>2025-08-07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29D6B-4211-4370-A671-07C90A0516A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799025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ABAAD-8FF2-4C05-9F9A-E686BFC8756C}" type="datetimeFigureOut">
              <a:rPr lang="ko-KR" altLang="en-US" smtClean="0"/>
              <a:t>2025-08-07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29D6B-4211-4370-A671-07C90A0516A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09802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ABAAD-8FF2-4C05-9F9A-E686BFC8756C}" type="datetimeFigureOut">
              <a:rPr lang="ko-KR" altLang="en-US" smtClean="0"/>
              <a:t>2025-08-0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29D6B-4211-4370-A671-07C90A0516A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946180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ABAAD-8FF2-4C05-9F9A-E686BFC8756C}" type="datetimeFigureOut">
              <a:rPr lang="ko-KR" altLang="en-US" smtClean="0"/>
              <a:t>2025-08-0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29D6B-4211-4370-A671-07C90A0516A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599352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C8ABAAD-8FF2-4C05-9F9A-E686BFC8756C}" type="datetimeFigureOut">
              <a:rPr lang="ko-KR" altLang="en-US" smtClean="0"/>
              <a:t>2025-08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D029D6B-4211-4370-A671-07C90A0516A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141913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19">
            <a:extLst>
              <a:ext uri="{FF2B5EF4-FFF2-40B4-BE49-F238E27FC236}">
                <a16:creationId xmlns:a16="http://schemas.microsoft.com/office/drawing/2014/main" id="{2CA5D5AF-A83F-5D5F-8359-4F88C8EE4F9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35625818"/>
              </p:ext>
            </p:extLst>
          </p:nvPr>
        </p:nvGraphicFramePr>
        <p:xfrm>
          <a:off x="488618" y="1428446"/>
          <a:ext cx="7473127" cy="43105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2" name="TextBox 11">
            <a:extLst>
              <a:ext uri="{FF2B5EF4-FFF2-40B4-BE49-F238E27FC236}">
                <a16:creationId xmlns:a16="http://schemas.microsoft.com/office/drawing/2014/main" id="{F368B08B-82F1-8661-DEE7-84871D3A5EC8}"/>
              </a:ext>
            </a:extLst>
          </p:cNvPr>
          <p:cNvSpPr txBox="1"/>
          <p:nvPr/>
        </p:nvSpPr>
        <p:spPr>
          <a:xfrm>
            <a:off x="-29548" y="39710"/>
            <a:ext cx="20730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3AB84CD-02E4-A9A7-8F9A-DC6D4F0A0AB4}"/>
              </a:ext>
            </a:extLst>
          </p:cNvPr>
          <p:cNvSpPr txBox="1"/>
          <p:nvPr/>
        </p:nvSpPr>
        <p:spPr>
          <a:xfrm>
            <a:off x="209034" y="6048892"/>
            <a:ext cx="865361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1</a:t>
            </a:r>
            <a:r>
              <a:rPr lang="en-US" altLang="ko-KR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. Body weight change.  </a:t>
            </a:r>
            <a:r>
              <a:rPr lang="en-US" altLang="ko-KR" sz="18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Body weight was assessed daily for </a:t>
            </a:r>
            <a:r>
              <a:rPr lang="en-US" altLang="ko-KR" sz="1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4 </a:t>
            </a:r>
            <a:r>
              <a:rPr lang="en-US" altLang="ko-KR" dirty="0">
                <a:solidFill>
                  <a:srgbClr val="FF0000"/>
                </a:solidFill>
                <a:latin typeface="Times New Roman" panose="02020603050405020304" pitchFamily="18" charset="0"/>
                <a:ea typeface="맑은 고딕" panose="020B0503020000020004" pitchFamily="50" charset="-127"/>
              </a:rPr>
              <a:t>weeks</a:t>
            </a:r>
            <a:r>
              <a:rPr lang="en-US" altLang="ko-KR" sz="1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. Significant differences are indicated as *P&lt;0.05 </a:t>
            </a:r>
            <a:r>
              <a:rPr lang="en-US" altLang="ko-KR" sz="180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with old </a:t>
            </a:r>
            <a:r>
              <a:rPr lang="en-US" altLang="ko-KR" sz="1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vehicle mice.    </a:t>
            </a:r>
            <a:endParaRPr lang="ko-KR" altLang="en-US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422031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테마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9</TotalTime>
  <Words>43</Words>
  <Application>Microsoft Office PowerPoint</Application>
  <PresentationFormat>화면 슬라이드 쇼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이종한</dc:creator>
  <cp:lastModifiedBy>이종한</cp:lastModifiedBy>
  <cp:revision>6</cp:revision>
  <dcterms:created xsi:type="dcterms:W3CDTF">2025-04-24T03:32:25Z</dcterms:created>
  <dcterms:modified xsi:type="dcterms:W3CDTF">2025-08-07T03:23:57Z</dcterms:modified>
</cp:coreProperties>
</file>